
<file path=[Content_Types].xml><?xml version="1.0" encoding="utf-8"?>
<Types xmlns="http://schemas.openxmlformats.org/package/2006/content-types">
  <Default Extension="jpeg" ContentType="image/jpeg"/>
  <Default Extension="JPG" ContentType="image/.jpg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9"/>
  </p:handoutMasterIdLst>
  <p:sldIdLst>
    <p:sldId id="256" r:id="rId3"/>
    <p:sldId id="257" r:id="rId5"/>
    <p:sldId id="262" r:id="rId6"/>
    <p:sldId id="258" r:id="rId7"/>
    <p:sldId id="259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0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Z" initials="Z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160"/>
        <p:guide pos="38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handoutMaster" Target="handoutMasters/handoutMaster1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commentAuthors" Target="commentAuthors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1ED644-ACF5-4249-806C-5CB2425C506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8.xml"/><Relationship Id="rId8" Type="http://schemas.openxmlformats.org/officeDocument/2006/relationships/tags" Target="../tags/tag7.xml"/><Relationship Id="rId7" Type="http://schemas.openxmlformats.org/officeDocument/2006/relationships/tags" Target="../tags/tag6.xml"/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0" Type="http://schemas.openxmlformats.org/officeDocument/2006/relationships/notesSlide" Target="../notesSlides/notesSlide2.xml"/><Relationship Id="rId4" Type="http://schemas.openxmlformats.org/officeDocument/2006/relationships/tags" Target="../tags/tag3.xml"/><Relationship Id="rId39" Type="http://schemas.openxmlformats.org/officeDocument/2006/relationships/slideLayout" Target="../slideLayouts/slideLayout1.xml"/><Relationship Id="rId38" Type="http://schemas.openxmlformats.org/officeDocument/2006/relationships/tags" Target="../tags/tag33.xml"/><Relationship Id="rId37" Type="http://schemas.openxmlformats.org/officeDocument/2006/relationships/tags" Target="../tags/tag32.xml"/><Relationship Id="rId36" Type="http://schemas.openxmlformats.org/officeDocument/2006/relationships/image" Target="../media/image6.png"/><Relationship Id="rId35" Type="http://schemas.openxmlformats.org/officeDocument/2006/relationships/tags" Target="../tags/tag31.xml"/><Relationship Id="rId34" Type="http://schemas.openxmlformats.org/officeDocument/2006/relationships/image" Target="../media/image5.png"/><Relationship Id="rId33" Type="http://schemas.openxmlformats.org/officeDocument/2006/relationships/image" Target="../media/image4.png"/><Relationship Id="rId32" Type="http://schemas.openxmlformats.org/officeDocument/2006/relationships/image" Target="../media/image3.png"/><Relationship Id="rId31" Type="http://schemas.openxmlformats.org/officeDocument/2006/relationships/tags" Target="../tags/tag30.xml"/><Relationship Id="rId30" Type="http://schemas.openxmlformats.org/officeDocument/2006/relationships/tags" Target="../tags/tag29.xml"/><Relationship Id="rId3" Type="http://schemas.openxmlformats.org/officeDocument/2006/relationships/tags" Target="../tags/tag2.xml"/><Relationship Id="rId29" Type="http://schemas.openxmlformats.org/officeDocument/2006/relationships/tags" Target="../tags/tag28.xml"/><Relationship Id="rId28" Type="http://schemas.openxmlformats.org/officeDocument/2006/relationships/tags" Target="../tags/tag27.xml"/><Relationship Id="rId27" Type="http://schemas.openxmlformats.org/officeDocument/2006/relationships/tags" Target="../tags/tag26.xml"/><Relationship Id="rId26" Type="http://schemas.openxmlformats.org/officeDocument/2006/relationships/tags" Target="../tags/tag25.xml"/><Relationship Id="rId25" Type="http://schemas.openxmlformats.org/officeDocument/2006/relationships/tags" Target="../tags/tag24.xml"/><Relationship Id="rId24" Type="http://schemas.openxmlformats.org/officeDocument/2006/relationships/tags" Target="../tags/tag23.xml"/><Relationship Id="rId23" Type="http://schemas.openxmlformats.org/officeDocument/2006/relationships/tags" Target="../tags/tag22.xml"/><Relationship Id="rId22" Type="http://schemas.openxmlformats.org/officeDocument/2006/relationships/tags" Target="../tags/tag21.xml"/><Relationship Id="rId21" Type="http://schemas.openxmlformats.org/officeDocument/2006/relationships/tags" Target="../tags/tag20.xml"/><Relationship Id="rId20" Type="http://schemas.openxmlformats.org/officeDocument/2006/relationships/tags" Target="../tags/tag19.xml"/><Relationship Id="rId2" Type="http://schemas.openxmlformats.org/officeDocument/2006/relationships/tags" Target="../tags/tag1.xml"/><Relationship Id="rId19" Type="http://schemas.openxmlformats.org/officeDocument/2006/relationships/tags" Target="../tags/tag18.xml"/><Relationship Id="rId18" Type="http://schemas.openxmlformats.org/officeDocument/2006/relationships/tags" Target="../tags/tag17.xml"/><Relationship Id="rId17" Type="http://schemas.openxmlformats.org/officeDocument/2006/relationships/tags" Target="../tags/tag16.xml"/><Relationship Id="rId16" Type="http://schemas.openxmlformats.org/officeDocument/2006/relationships/tags" Target="../tags/tag15.xml"/><Relationship Id="rId15" Type="http://schemas.openxmlformats.org/officeDocument/2006/relationships/tags" Target="../tags/tag14.xml"/><Relationship Id="rId14" Type="http://schemas.openxmlformats.org/officeDocument/2006/relationships/tags" Target="../tags/tag13.xml"/><Relationship Id="rId13" Type="http://schemas.openxmlformats.org/officeDocument/2006/relationships/tags" Target="../tags/tag12.xml"/><Relationship Id="rId12" Type="http://schemas.openxmlformats.org/officeDocument/2006/relationships/tags" Target="../tags/tag11.xml"/><Relationship Id="rId11" Type="http://schemas.openxmlformats.org/officeDocument/2006/relationships/tags" Target="../tags/tag10.xml"/><Relationship Id="rId10" Type="http://schemas.openxmlformats.org/officeDocument/2006/relationships/tags" Target="../tags/tag9.xml"/><Relationship Id="rId1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1453515" y="5243195"/>
            <a:ext cx="9476740" cy="175323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just"/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</a:rPr>
              <a:t>Supporting Information S1: Figure 1</a:t>
            </a:r>
            <a:r>
              <a:rPr lang="en-US" sz="12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| 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OsNAC78 positively regulates resistance to rice blast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. 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(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A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) Photographs showing the field blast resistance of </a:t>
            </a:r>
            <a:r>
              <a:rPr lang="zh-CN" altLang="en-US" sz="1200" i="1">
                <a:latin typeface="Times New Roman" panose="02020603050405020304" charset="0"/>
                <a:cs typeface="Times New Roman" panose="02020603050405020304" charset="0"/>
              </a:rPr>
              <a:t>Osnac78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 mutants in the natural rice blast nursery. Red arrows represent lesions induced by M.oryzae. Enlarged images of the boxed areas are shown on the right.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(B) The fungal biomass of the isolate was calculated by qRT-PCR using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MoPot2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/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OsUbq5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. Values represent the mean±SE (n=3, n means biological replicate). Statistical significance was determined by one-way ANOVA (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&lt;0.05). </a:t>
            </a:r>
            <a:r>
              <a:rPr lang="en-US" altLang="zh-CN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(C) Photographs of OsNAC78 over-expression lines at 7 days post punch-inoculation with the Guy11 isolate. (D) Vertical lengths of lesions induced by Guy11 were measured. Values represent the mean</a:t>
            </a:r>
            <a:r>
              <a:rPr lang="en-US" alt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±</a:t>
            </a:r>
            <a:r>
              <a:rPr lang="en-US" altLang="zh-CN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SE (n=10, n means biological replicate). Statistical significance was determined by one-way ANOVA (</a:t>
            </a:r>
            <a:r>
              <a:rPr lang="en-US" altLang="zh-CN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&lt;0.05). (E) The fungal biomass of the Guy11 isolate was calculated by RT-qPCR using MoPot2/OsUbq5. Values represent the mean</a:t>
            </a:r>
            <a:r>
              <a:rPr lang="en-US" alt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±</a:t>
            </a:r>
            <a:r>
              <a:rPr lang="en-US" altLang="zh-CN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SE (n=3, n means biological replicate). Statistical significance was determined by one-way ANOVA (</a:t>
            </a:r>
            <a:r>
              <a:rPr lang="en-US" altLang="zh-CN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&lt;0.05).</a:t>
            </a:r>
            <a:endParaRPr lang="en-US" altLang="zh-CN" sz="12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  <a:sym typeface="+mn-ea"/>
            </a:endParaRPr>
          </a:p>
          <a:p>
            <a:pPr algn="just"/>
            <a:endParaRPr lang="en-US" altLang="zh-CN" sz="12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071495" y="491490"/>
            <a:ext cx="5600065" cy="477647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2029460" y="5219065"/>
            <a:ext cx="8517890" cy="101473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orting Information S1: Figure 2</a:t>
            </a:r>
            <a:r>
              <a:rPr lang="en-US" sz="12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| 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Knockout site and overexpression of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ir7b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in </a:t>
            </a:r>
            <a:r>
              <a:rPr lang="en-US" sz="120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Nipponbare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background. (A) The schematic of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ir7b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genome. Target sites of CRISPR/Cas9 were both designed on the First exon.  (B) The site of base mutation. 1-bp deletion was detected in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ir7b-1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mutant. 2-bp deletion was detected in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ir7b-2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mutant. (C) Sequencing peak map of mutation sites. (D)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ir7b 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expression levels in WT (Nip) measured using qRT-PCR. The expression level in the Nip is set to 1.0, and error bars represent the se of three independent experiments. 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Statistical significance was determined by one-way ANOVA (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&lt;0.05).</a:t>
            </a:r>
            <a:endParaRPr lang="en-US" sz="12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 rot="0">
            <a:off x="7382510" y="863600"/>
            <a:ext cx="3077845" cy="3822700"/>
            <a:chOff x="11056" y="1115"/>
            <a:chExt cx="4847" cy="602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11620" y="1428"/>
              <a:ext cx="4283" cy="5707"/>
            </a:xfrm>
            <a:prstGeom prst="rect">
              <a:avLst/>
            </a:prstGeom>
          </p:spPr>
        </p:pic>
        <p:sp>
          <p:nvSpPr>
            <p:cNvPr id="5" name="文本框 4"/>
            <p:cNvSpPr txBox="1"/>
            <p:nvPr/>
          </p:nvSpPr>
          <p:spPr>
            <a:xfrm>
              <a:off x="11056" y="1115"/>
              <a:ext cx="438" cy="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900" b="1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altLang="zh-CN" sz="9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1093470" y="664845"/>
            <a:ext cx="7051675" cy="4176395"/>
            <a:chOff x="5534" y="1516"/>
            <a:chExt cx="11105" cy="6577"/>
          </a:xfrm>
        </p:grpSpPr>
        <p:sp>
          <p:nvSpPr>
            <p:cNvPr id="6" name="文本框 5"/>
            <p:cNvSpPr txBox="1"/>
            <p:nvPr>
              <p:custDataLst>
                <p:tags r:id="rId2"/>
              </p:custDataLst>
            </p:nvPr>
          </p:nvSpPr>
          <p:spPr>
            <a:xfrm>
              <a:off x="5534" y="1829"/>
              <a:ext cx="25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7050" y="2667"/>
              <a:ext cx="8639" cy="406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p>
              <a:r>
                <a:rPr lang="zh-CN" altLang="en-US" sz="700" b="1">
                  <a:latin typeface="Arial" panose="020B0604020202020204" pitchFamily="34" charset="0"/>
                  <a:cs typeface="Arial" panose="020B0604020202020204" pitchFamily="34" charset="0"/>
                </a:rPr>
                <a:t>CATCCTGGTCCACGGCCTCTGCCACGGCGCG</a:t>
              </a:r>
              <a:r>
                <a:rPr lang="en-US" altLang="zh-CN" sz="700" b="1">
                  <a:latin typeface="Arial" panose="020B0604020202020204" pitchFamily="34" charset="0"/>
                  <a:cs typeface="Arial" panose="020B0604020202020204" pitchFamily="34" charset="0"/>
                </a:rPr>
                <a:t>            GCGCTCGACATGGCCGCGTCGGG       </a:t>
              </a:r>
              <a:endParaRPr lang="en-US" altLang="zh-CN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>
              <p:custDataLst>
                <p:tags r:id="rId3"/>
              </p:custDataLst>
            </p:nvPr>
          </p:nvSpPr>
          <p:spPr>
            <a:xfrm>
              <a:off x="6546" y="2760"/>
              <a:ext cx="644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7047" y="2903"/>
              <a:ext cx="6135" cy="31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p>
              <a:pPr indent="0"/>
              <a:r>
                <a:rPr lang="en-US" sz="700" b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EISSSSKKHFILVHGLCHGAWCWYRVVAALRAA</a:t>
              </a:r>
              <a:r>
                <a:rPr lang="en-US" sz="700" b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GHRATALDMAASGAHP</a:t>
              </a:r>
              <a:r>
                <a:rPr lang="en-US" sz="700" b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......IKIANKYE*</a:t>
              </a:r>
              <a:endParaRPr lang="en-US" sz="700" b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6" name="文本框 15"/>
            <p:cNvSpPr txBox="1"/>
            <p:nvPr>
              <p:custDataLst>
                <p:tags r:id="rId4"/>
              </p:custDataLst>
            </p:nvPr>
          </p:nvSpPr>
          <p:spPr>
            <a:xfrm>
              <a:off x="5534" y="2728"/>
              <a:ext cx="25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altLang="zh-CN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>
              <p:custDataLst>
                <p:tags r:id="rId5"/>
              </p:custDataLst>
            </p:nvPr>
          </p:nvSpPr>
          <p:spPr>
            <a:xfrm>
              <a:off x="7039" y="3278"/>
              <a:ext cx="8773" cy="406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p>
              <a:r>
                <a:rPr lang="zh-CN" altLang="en-US" sz="7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ATCCTGGTCCACGGCCTCTGC</a:t>
              </a:r>
              <a:r>
                <a:rPr lang="en-US" altLang="zh-CN" sz="7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   </a:t>
              </a:r>
              <a:r>
                <a:rPr lang="zh-CN" altLang="en-US" sz="7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CGGCGCG</a:t>
              </a:r>
              <a:r>
                <a:rPr lang="en-US" altLang="zh-CN" sz="7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           GCGCTCGACATGGCCGCGTCGGG  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/>
            <p:cNvSpPr txBox="1"/>
            <p:nvPr>
              <p:custDataLst>
                <p:tags r:id="rId6"/>
              </p:custDataLst>
            </p:nvPr>
          </p:nvSpPr>
          <p:spPr>
            <a:xfrm>
              <a:off x="8997" y="3073"/>
              <a:ext cx="1040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bp deletion</a:t>
              </a:r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/>
            <p:cNvSpPr txBox="1"/>
            <p:nvPr>
              <p:custDataLst>
                <p:tags r:id="rId7"/>
              </p:custDataLst>
            </p:nvPr>
          </p:nvSpPr>
          <p:spPr>
            <a:xfrm>
              <a:off x="5983" y="3371"/>
              <a:ext cx="1112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1bp</a:t>
              </a:r>
              <a:r>
                <a:rPr lang="en-US" altLang="zh-CN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pir7b-1</a:t>
              </a:r>
              <a:endParaRPr lang="en-US" altLang="zh-CN" sz="7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7039" y="3502"/>
              <a:ext cx="6416" cy="313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p>
              <a:pPr indent="0"/>
              <a:r>
                <a:rPr lang="en-US" sz="700" b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EISSSSKKHFILVHGLC</a:t>
              </a:r>
              <a:r>
                <a:rPr lang="en-US" sz="700" b="1">
                  <a:solidFill>
                    <a:srgbClr val="FF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ARGAGTGWSPRCAPRGTARRRSTWPRRARTR</a:t>
              </a:r>
              <a:r>
                <a:rPr lang="en-US" sz="700" b="1">
                  <a:solidFill>
                    <a:srgbClr val="FF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......W</a:t>
              </a:r>
              <a:r>
                <a:rPr lang="en-US" sz="700" b="1">
                  <a:solidFill>
                    <a:srgbClr val="FF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SRPRSS*</a:t>
              </a:r>
              <a:endParaRPr lang="en-US" sz="7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3" name="文本框 52"/>
            <p:cNvSpPr txBox="1"/>
            <p:nvPr>
              <p:custDataLst>
                <p:tags r:id="rId8"/>
              </p:custDataLst>
            </p:nvPr>
          </p:nvSpPr>
          <p:spPr>
            <a:xfrm>
              <a:off x="5984" y="1862"/>
              <a:ext cx="1336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ir7b </a:t>
              </a:r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genome</a:t>
              </a:r>
              <a:endPara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组合 7"/>
            <p:cNvGrpSpPr/>
            <p:nvPr/>
          </p:nvGrpSpPr>
          <p:grpSpPr>
            <a:xfrm rot="0">
              <a:off x="7769" y="1516"/>
              <a:ext cx="4018" cy="1077"/>
              <a:chOff x="7673" y="1654"/>
              <a:chExt cx="2434" cy="1077"/>
            </a:xfrm>
          </p:grpSpPr>
          <p:sp>
            <p:nvSpPr>
              <p:cNvPr id="49" name="等腰三角形 48"/>
              <p:cNvSpPr/>
              <p:nvPr>
                <p:custDataLst>
                  <p:tags r:id="rId9"/>
                </p:custDataLst>
              </p:nvPr>
            </p:nvSpPr>
            <p:spPr>
              <a:xfrm flipV="1">
                <a:off x="7951" y="2000"/>
                <a:ext cx="133" cy="120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本框 51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7673" y="1654"/>
                <a:ext cx="749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arget site 1</a:t>
                </a:r>
                <a:endPara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等腰三角形 54"/>
              <p:cNvSpPr/>
              <p:nvPr>
                <p:custDataLst>
                  <p:tags r:id="rId11"/>
                </p:custDataLst>
              </p:nvPr>
            </p:nvSpPr>
            <p:spPr>
              <a:xfrm>
                <a:off x="7981" y="2299"/>
                <a:ext cx="133" cy="1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 sz="7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文本框 181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7701" y="2418"/>
                <a:ext cx="692" cy="3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arget site 2</a:t>
                </a:r>
                <a:endPara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" name="组合 9"/>
              <p:cNvGrpSpPr/>
              <p:nvPr/>
            </p:nvGrpSpPr>
            <p:grpSpPr>
              <a:xfrm>
                <a:off x="7830" y="2142"/>
                <a:ext cx="2277" cy="162"/>
                <a:chOff x="7235" y="2246"/>
                <a:chExt cx="1809" cy="162"/>
              </a:xfrm>
            </p:grpSpPr>
            <p:grpSp>
              <p:nvGrpSpPr>
                <p:cNvPr id="161" name="组合 160"/>
                <p:cNvGrpSpPr/>
                <p:nvPr/>
              </p:nvGrpSpPr>
              <p:grpSpPr>
                <a:xfrm rot="0">
                  <a:off x="7331" y="2247"/>
                  <a:ext cx="1713" cy="161"/>
                  <a:chOff x="2639" y="967"/>
                  <a:chExt cx="2894" cy="178"/>
                </a:xfrm>
                <a:solidFill>
                  <a:srgbClr val="00B050"/>
                </a:solidFill>
              </p:grpSpPr>
              <p:cxnSp>
                <p:nvCxnSpPr>
                  <p:cNvPr id="163" name="直接连接符 162"/>
                  <p:cNvCxnSpPr>
                    <a:endCxn id="171" idx="3"/>
                  </p:cNvCxnSpPr>
                  <p:nvPr>
                    <p:custDataLst>
                      <p:tags r:id="rId13"/>
                    </p:custDataLst>
                  </p:nvPr>
                </p:nvCxnSpPr>
                <p:spPr>
                  <a:xfrm>
                    <a:off x="2639" y="1047"/>
                    <a:ext cx="2894" cy="12"/>
                  </a:xfrm>
                  <a:prstGeom prst="line">
                    <a:avLst/>
                  </a:prstGeom>
                  <a:grpFill/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4" name="矩形 163"/>
                  <p:cNvSpPr/>
                  <p:nvPr>
                    <p:custDataLst>
                      <p:tags r:id="rId14"/>
                    </p:custDataLst>
                  </p:nvPr>
                </p:nvSpPr>
                <p:spPr>
                  <a:xfrm>
                    <a:off x="2664" y="967"/>
                    <a:ext cx="504" cy="152"/>
                  </a:xfrm>
                  <a:prstGeom prst="rect">
                    <a:avLst/>
                  </a:prstGeom>
                  <a:solidFill>
                    <a:srgbClr val="00B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9" name="矩形 168"/>
                  <p:cNvSpPr/>
                  <p:nvPr>
                    <p:custDataLst>
                      <p:tags r:id="rId15"/>
                    </p:custDataLst>
                  </p:nvPr>
                </p:nvSpPr>
                <p:spPr>
                  <a:xfrm>
                    <a:off x="3530" y="977"/>
                    <a:ext cx="267" cy="156"/>
                  </a:xfrm>
                  <a:prstGeom prst="rect">
                    <a:avLst/>
                  </a:prstGeom>
                  <a:solidFill>
                    <a:srgbClr val="00B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1" name="矩形 170"/>
                  <p:cNvSpPr/>
                  <p:nvPr>
                    <p:custDataLst>
                      <p:tags r:id="rId16"/>
                    </p:custDataLst>
                  </p:nvPr>
                </p:nvSpPr>
                <p:spPr>
                  <a:xfrm>
                    <a:off x="4761" y="973"/>
                    <a:ext cx="772" cy="172"/>
                  </a:xfrm>
                  <a:prstGeom prst="rect">
                    <a:avLst/>
                  </a:prstGeom>
                  <a:solidFill>
                    <a:srgbClr val="00B050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p>
                    <a:pPr algn="ctr"/>
                    <a:endParaRPr lang="zh-CN" altLang="en-US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4" name="矩形 13"/>
                <p:cNvSpPr/>
                <p:nvPr>
                  <p:custDataLst>
                    <p:tags r:id="rId17"/>
                  </p:custDataLst>
                </p:nvPr>
              </p:nvSpPr>
              <p:spPr>
                <a:xfrm>
                  <a:off x="7235" y="2246"/>
                  <a:ext cx="120" cy="141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2" name="文本框 21"/>
            <p:cNvSpPr txBox="1"/>
            <p:nvPr>
              <p:custDataLst>
                <p:tags r:id="rId18"/>
              </p:custDataLst>
            </p:nvPr>
          </p:nvSpPr>
          <p:spPr>
            <a:xfrm>
              <a:off x="10286" y="3201"/>
              <a:ext cx="61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……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/>
            <p:cNvSpPr txBox="1"/>
            <p:nvPr>
              <p:custDataLst>
                <p:tags r:id="rId19"/>
              </p:custDataLst>
            </p:nvPr>
          </p:nvSpPr>
          <p:spPr>
            <a:xfrm>
              <a:off x="5534" y="4738"/>
              <a:ext cx="257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altLang="zh-CN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>
              <p:custDataLst>
                <p:tags r:id="rId20"/>
              </p:custDataLst>
            </p:nvPr>
          </p:nvSpPr>
          <p:spPr>
            <a:xfrm>
              <a:off x="5982" y="4001"/>
              <a:ext cx="1321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2bp</a:t>
              </a:r>
              <a:r>
                <a:rPr lang="en-US" altLang="zh-CN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pir7b-2</a:t>
              </a:r>
              <a:endParaRPr lang="en-US" altLang="zh-CN" sz="7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7039" y="3951"/>
              <a:ext cx="9600" cy="31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r>
                <a:rPr lang="zh-CN" altLang="en-US" sz="7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CATCCTGGTCCACGGCCTCTGCCACGGCGCG</a:t>
              </a:r>
              <a:r>
                <a:rPr lang="en-US" altLang="zh-CN" sz="700" b="1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            GCGCTCGACATGGCCG      TCGGG</a:t>
              </a:r>
              <a:endParaRPr lang="en-US" altLang="zh-CN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99"/>
            <p:cNvSpPr txBox="1"/>
            <p:nvPr/>
          </p:nvSpPr>
          <p:spPr>
            <a:xfrm>
              <a:off x="7048" y="4222"/>
              <a:ext cx="8000" cy="313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p>
              <a:pPr indent="0"/>
              <a:r>
                <a:rPr lang="en-US" sz="700" b="1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EISSSSKKHFILVHGLCHGAWCWYRVVAALRAAGHRATALDMA</a:t>
              </a:r>
              <a:r>
                <a:rPr lang="en-US" sz="700" b="1">
                  <a:solidFill>
                    <a:srgbClr val="FF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VGRAPG</a:t>
              </a:r>
              <a:r>
                <a:rPr lang="en-US" sz="700" b="1">
                  <a:solidFill>
                    <a:srgbClr val="FF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  <a:sym typeface="+mn-ea"/>
                </a:rPr>
                <a:t>......</a:t>
              </a:r>
              <a:r>
                <a:rPr lang="en-US" sz="700" b="1">
                  <a:solidFill>
                    <a:srgbClr val="FF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VHEKNCT*</a:t>
              </a:r>
              <a:endParaRPr lang="en-US" altLang="en-US" sz="7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>
              <p:custDataLst>
                <p:tags r:id="rId21"/>
              </p:custDataLst>
            </p:nvPr>
          </p:nvSpPr>
          <p:spPr>
            <a:xfrm>
              <a:off x="12041" y="3794"/>
              <a:ext cx="1200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bp deletion</a:t>
              </a:r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直接连接符 29"/>
            <p:cNvCxnSpPr/>
            <p:nvPr>
              <p:custDataLst>
                <p:tags r:id="rId22"/>
              </p:custDataLst>
            </p:nvPr>
          </p:nvCxnSpPr>
          <p:spPr>
            <a:xfrm>
              <a:off x="9393" y="3435"/>
              <a:ext cx="113" cy="0"/>
            </a:xfrm>
            <a:prstGeom prst="line">
              <a:avLst/>
            </a:prstGeom>
            <a:ln w="19050">
              <a:solidFill>
                <a:sysClr val="windowText" lastClr="000000"/>
              </a:solidFill>
            </a:ln>
          </p:spPr>
          <p:style>
            <a:lnRef idx="1">
              <a:srgbClr val="4472C4"/>
            </a:lnRef>
            <a:fillRef idx="0">
              <a:srgbClr val="4472C4"/>
            </a:fillRef>
            <a:effectRef idx="0">
              <a:srgbClr val="4472C4"/>
            </a:effectRef>
            <a:fontRef idx="minor">
              <a:sysClr val="windowText" lastClr="000000"/>
            </a:fontRef>
          </p:style>
        </p:cxnSp>
        <p:sp>
          <p:nvSpPr>
            <p:cNvPr id="34" name="文本框 33"/>
            <p:cNvSpPr txBox="1"/>
            <p:nvPr>
              <p:custDataLst>
                <p:tags r:id="rId23"/>
              </p:custDataLst>
            </p:nvPr>
          </p:nvSpPr>
          <p:spPr>
            <a:xfrm>
              <a:off x="10286" y="2590"/>
              <a:ext cx="61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……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/>
            <p:cNvSpPr txBox="1"/>
            <p:nvPr>
              <p:custDataLst>
                <p:tags r:id="rId24"/>
              </p:custDataLst>
            </p:nvPr>
          </p:nvSpPr>
          <p:spPr>
            <a:xfrm>
              <a:off x="10286" y="3916"/>
              <a:ext cx="61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……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>
              <p:custDataLst>
                <p:tags r:id="rId25"/>
              </p:custDataLst>
            </p:nvPr>
          </p:nvSpPr>
          <p:spPr>
            <a:xfrm>
              <a:off x="5984" y="5401"/>
              <a:ext cx="1258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1bp</a:t>
              </a:r>
              <a:r>
                <a:rPr lang="en-US" altLang="zh-CN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pir7b-1</a:t>
              </a:r>
              <a:endParaRPr lang="en-US" altLang="zh-CN" sz="7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/>
            <p:cNvSpPr txBox="1"/>
            <p:nvPr>
              <p:custDataLst>
                <p:tags r:id="rId26"/>
              </p:custDataLst>
            </p:nvPr>
          </p:nvSpPr>
          <p:spPr>
            <a:xfrm>
              <a:off x="5982" y="7269"/>
              <a:ext cx="1208" cy="3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2bp</a:t>
              </a:r>
              <a:r>
                <a:rPr lang="en-US" altLang="zh-CN" sz="7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pir7b-2</a:t>
              </a:r>
              <a:endParaRPr lang="en-US" altLang="zh-CN" sz="7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/>
            <p:cNvSpPr txBox="1"/>
            <p:nvPr>
              <p:custDataLst>
                <p:tags r:id="rId27"/>
              </p:custDataLst>
            </p:nvPr>
          </p:nvSpPr>
          <p:spPr>
            <a:xfrm>
              <a:off x="9506" y="7269"/>
              <a:ext cx="617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……</a:t>
              </a:r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8" name="直接连接符 87"/>
            <p:cNvCxnSpPr/>
            <p:nvPr>
              <p:custDataLst>
                <p:tags r:id="rId28"/>
              </p:custDataLst>
            </p:nvPr>
          </p:nvCxnSpPr>
          <p:spPr>
            <a:xfrm>
              <a:off x="12429" y="4107"/>
              <a:ext cx="227" cy="0"/>
            </a:xfrm>
            <a:prstGeom prst="line">
              <a:avLst/>
            </a:prstGeom>
            <a:ln w="19050">
              <a:solidFill>
                <a:sysClr val="windowText" lastClr="000000"/>
              </a:solidFill>
            </a:ln>
          </p:spPr>
          <p:style>
            <a:lnRef idx="1">
              <a:srgbClr val="4472C4"/>
            </a:lnRef>
            <a:fillRef idx="0">
              <a:srgbClr val="4472C4"/>
            </a:fillRef>
            <a:effectRef idx="0">
              <a:srgbClr val="4472C4"/>
            </a:effectRef>
            <a:fontRef idx="minor">
              <a:sysClr val="windowText" lastClr="000000"/>
            </a:fontRef>
          </p:style>
        </p:cxnSp>
        <p:grpSp>
          <p:nvGrpSpPr>
            <p:cNvPr id="102" name="组合 101"/>
            <p:cNvGrpSpPr/>
            <p:nvPr/>
          </p:nvGrpSpPr>
          <p:grpSpPr>
            <a:xfrm>
              <a:off x="7096" y="4572"/>
              <a:ext cx="8366" cy="1631"/>
              <a:chOff x="7096" y="4631"/>
              <a:chExt cx="8366" cy="1631"/>
            </a:xfrm>
          </p:grpSpPr>
          <p:grpSp>
            <p:nvGrpSpPr>
              <p:cNvPr id="76" name="组合 75"/>
              <p:cNvGrpSpPr/>
              <p:nvPr/>
            </p:nvGrpSpPr>
            <p:grpSpPr>
              <a:xfrm rot="0">
                <a:off x="9972" y="4631"/>
                <a:ext cx="463" cy="427"/>
                <a:chOff x="9064" y="4624"/>
                <a:chExt cx="463" cy="427"/>
              </a:xfrm>
            </p:grpSpPr>
            <p:sp>
              <p:nvSpPr>
                <p:cNvPr id="74" name="文本框 73"/>
                <p:cNvSpPr txBox="1"/>
                <p:nvPr>
                  <p:custDataLst>
                    <p:tags r:id="rId29"/>
                  </p:custDataLst>
                </p:nvPr>
              </p:nvSpPr>
              <p:spPr>
                <a:xfrm>
                  <a:off x="9064" y="4624"/>
                  <a:ext cx="463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C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微软雅黑" panose="020B0503020204020204" charset="-122"/>
                  </a:endParaRPr>
                </a:p>
              </p:txBody>
            </p:sp>
            <p:sp>
              <p:nvSpPr>
                <p:cNvPr id="35" name="等腰三角形 34"/>
                <p:cNvSpPr/>
                <p:nvPr>
                  <p:custDataLst>
                    <p:tags r:id="rId30"/>
                  </p:custDataLst>
                </p:nvPr>
              </p:nvSpPr>
              <p:spPr>
                <a:xfrm flipV="1">
                  <a:off x="9213" y="4931"/>
                  <a:ext cx="165" cy="120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 sz="7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6" name="组合 95"/>
              <p:cNvGrpSpPr/>
              <p:nvPr/>
            </p:nvGrpSpPr>
            <p:grpSpPr>
              <a:xfrm>
                <a:off x="7096" y="5066"/>
                <a:ext cx="8366" cy="1196"/>
                <a:chOff x="7050" y="5154"/>
                <a:chExt cx="8366" cy="1426"/>
              </a:xfrm>
            </p:grpSpPr>
            <p:sp>
              <p:nvSpPr>
                <p:cNvPr id="21" name="文本框 20"/>
                <p:cNvSpPr txBox="1"/>
                <p:nvPr>
                  <p:custDataLst>
                    <p:tags r:id="rId31"/>
                  </p:custDataLst>
                </p:nvPr>
              </p:nvSpPr>
              <p:spPr>
                <a:xfrm>
                  <a:off x="11519" y="5606"/>
                  <a:ext cx="617" cy="5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……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89" name="图片 88"/>
                <p:cNvPicPr>
                  <a:picLocks noChangeAspect="1"/>
                </p:cNvPicPr>
                <p:nvPr/>
              </p:nvPicPr>
              <p:blipFill>
                <a:blip r:embed="rId32"/>
                <a:srcRect l="647" r="35863"/>
                <a:stretch>
                  <a:fillRect/>
                </a:stretch>
              </p:blipFill>
              <p:spPr>
                <a:xfrm>
                  <a:off x="7050" y="5154"/>
                  <a:ext cx="4252" cy="1426"/>
                </a:xfrm>
                <a:prstGeom prst="rect">
                  <a:avLst/>
                </a:prstGeom>
              </p:spPr>
            </p:pic>
            <p:pic>
              <p:nvPicPr>
                <p:cNvPr id="93" name="图片 92"/>
                <p:cNvPicPr>
                  <a:picLocks noChangeAspect="1"/>
                </p:cNvPicPr>
                <p:nvPr/>
              </p:nvPicPr>
              <p:blipFill>
                <a:blip r:embed="rId33"/>
                <a:stretch>
                  <a:fillRect/>
                </a:stretch>
              </p:blipFill>
              <p:spPr>
                <a:xfrm>
                  <a:off x="12100" y="5158"/>
                  <a:ext cx="3316" cy="1417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101" name="组合 100"/>
            <p:cNvGrpSpPr/>
            <p:nvPr/>
          </p:nvGrpSpPr>
          <p:grpSpPr>
            <a:xfrm>
              <a:off x="7008" y="6467"/>
              <a:ext cx="8080" cy="1627"/>
              <a:chOff x="7004" y="6679"/>
              <a:chExt cx="8080" cy="1627"/>
            </a:xfrm>
          </p:grpSpPr>
          <p:grpSp>
            <p:nvGrpSpPr>
              <p:cNvPr id="94" name="组合 93"/>
              <p:cNvGrpSpPr/>
              <p:nvPr/>
            </p:nvGrpSpPr>
            <p:grpSpPr>
              <a:xfrm>
                <a:off x="7004" y="7088"/>
                <a:ext cx="8081" cy="1219"/>
                <a:chOff x="7010" y="6873"/>
                <a:chExt cx="8081" cy="1420"/>
              </a:xfrm>
            </p:grpSpPr>
            <p:pic>
              <p:nvPicPr>
                <p:cNvPr id="90" name="图片 89"/>
                <p:cNvPicPr>
                  <a:picLocks noChangeAspect="1"/>
                </p:cNvPicPr>
                <p:nvPr/>
              </p:nvPicPr>
              <p:blipFill>
                <a:blip r:embed="rId34"/>
                <a:srcRect l="13469" t="2352" r="814" b="2650"/>
                <a:stretch>
                  <a:fillRect/>
                </a:stretch>
              </p:blipFill>
              <p:spPr>
                <a:xfrm>
                  <a:off x="7010" y="6873"/>
                  <a:ext cx="4572" cy="1420"/>
                </a:xfrm>
                <a:prstGeom prst="rect">
                  <a:avLst/>
                </a:prstGeom>
              </p:spPr>
            </p:pic>
            <p:sp>
              <p:nvSpPr>
                <p:cNvPr id="91" name="文本框 90"/>
                <p:cNvSpPr txBox="1"/>
                <p:nvPr>
                  <p:custDataLst>
                    <p:tags r:id="rId35"/>
                  </p:custDataLst>
                </p:nvPr>
              </p:nvSpPr>
              <p:spPr>
                <a:xfrm>
                  <a:off x="11567" y="7527"/>
                  <a:ext cx="617" cy="5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……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92" name="图片 91"/>
                <p:cNvPicPr>
                  <a:picLocks noChangeAspect="1"/>
                </p:cNvPicPr>
                <p:nvPr/>
              </p:nvPicPr>
              <p:blipFill>
                <a:blip r:embed="rId36"/>
                <a:srcRect r="19215"/>
                <a:stretch>
                  <a:fillRect/>
                </a:stretch>
              </p:blipFill>
              <p:spPr>
                <a:xfrm>
                  <a:off x="12148" y="6873"/>
                  <a:ext cx="2943" cy="1417"/>
                </a:xfrm>
                <a:prstGeom prst="rect">
                  <a:avLst/>
                </a:prstGeom>
              </p:spPr>
            </p:pic>
          </p:grpSp>
          <p:grpSp>
            <p:nvGrpSpPr>
              <p:cNvPr id="97" name="组合 96"/>
              <p:cNvGrpSpPr/>
              <p:nvPr/>
            </p:nvGrpSpPr>
            <p:grpSpPr>
              <a:xfrm rot="0">
                <a:off x="14076" y="6679"/>
                <a:ext cx="548" cy="409"/>
                <a:chOff x="9021" y="4642"/>
                <a:chExt cx="548" cy="409"/>
              </a:xfrm>
            </p:grpSpPr>
            <p:sp>
              <p:nvSpPr>
                <p:cNvPr id="98" name="文本框 97"/>
                <p:cNvSpPr txBox="1"/>
                <p:nvPr>
                  <p:custDataLst>
                    <p:tags r:id="rId37"/>
                  </p:custDataLst>
                </p:nvPr>
              </p:nvSpPr>
              <p:spPr>
                <a:xfrm>
                  <a:off x="9021" y="4642"/>
                  <a:ext cx="548" cy="2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CG</a:t>
                  </a:r>
                  <a:endPara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  <a:sym typeface="微软雅黑" panose="020B0503020204020204" charset="-122"/>
                  </a:endParaRPr>
                </a:p>
              </p:txBody>
            </p:sp>
            <p:sp>
              <p:nvSpPr>
                <p:cNvPr id="99" name="等腰三角形 98"/>
                <p:cNvSpPr/>
                <p:nvPr>
                  <p:custDataLst>
                    <p:tags r:id="rId38"/>
                  </p:custDataLst>
                </p:nvPr>
              </p:nvSpPr>
              <p:spPr>
                <a:xfrm flipV="1">
                  <a:off x="9213" y="4931"/>
                  <a:ext cx="165" cy="120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 sz="7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0" name="文本框 99"/>
          <p:cNvSpPr txBox="1"/>
          <p:nvPr/>
        </p:nvSpPr>
        <p:spPr>
          <a:xfrm>
            <a:off x="1521460" y="5234305"/>
            <a:ext cx="8613140" cy="101473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just"/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orting Information S1: Figure 3</a:t>
            </a:r>
            <a:r>
              <a:rPr lang="en-US" sz="12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| </a:t>
            </a:r>
            <a:r>
              <a:rPr lang="en-US" altLang="zh-CN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Detection of ROS in Pir7b transgenic rice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. </a:t>
            </a:r>
            <a:r>
              <a:rPr lang="en-US" altLang="zh-CN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(A) DAB staining of leaves to access H2O2 contents in Nip (WT), pir7b and OE-Pir7b transgenic plants. H2O2 content (B), MDA content (C), POD activity (D) , CAT activity (E), and SOD activity (F). FW, Fresh weight. Values represent the means </a:t>
            </a:r>
            <a:r>
              <a:rPr lang="en-US" alt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±</a:t>
            </a:r>
            <a:r>
              <a:rPr lang="en-US" altLang="zh-CN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SDs (n = 3, n means biological replicate). Statistical significance was determined by one-way ANOVA (P &lt; 0.05).</a:t>
            </a:r>
            <a:endParaRPr lang="en-US" altLang="zh-CN" sz="12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indent="0" algn="just"/>
            <a:endParaRPr lang="en-US" altLang="zh-CN" sz="12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16175" y="90805"/>
            <a:ext cx="6505575" cy="5092065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99"/>
          <p:cNvSpPr txBox="1"/>
          <p:nvPr/>
        </p:nvSpPr>
        <p:spPr>
          <a:xfrm>
            <a:off x="1285875" y="5093335"/>
            <a:ext cx="9620250" cy="119888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just"/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orting Information S1: Figure 4</a:t>
            </a:r>
            <a:r>
              <a:rPr lang="en-US" sz="12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| 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hylogenetic tree of Pir7b related proteins. Numbers at each branch indicate the bootstrap values for the node supported in 1000 bootstrap replicates.The protein names and gene symbol as follows: NP_001388588.1, LOC4326788; XP_044337741.1, LOC123059179; XP_044351726.1, LOC123072222; XP_008674587.2, LOC103650797; XP_035822241.1, LOC123072222; XP_003519919.2, LOC100813562; NP_001402058.1, LOC100818925; NP_001240864.1, LOC100796281; XP_044360040.1, LOC123081541; NP_001237816.2, LOC100527557; XP_008655980.1, LOC103635265; XP_003518092.1, LOC100787862; XP_044377786.1, LOC123099749; XP_044328761.1, LOC123049977; XP_008674949.1, LOC103651128; XP_015630567.1, LOC4324570; XP_015642328.1, LOC4326282</a:t>
            </a:r>
            <a:endParaRPr lang="en-US" altLang="en-US" sz="12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128010" y="326390"/>
            <a:ext cx="4521200" cy="4718685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0" name="文本框 99"/>
          <p:cNvSpPr txBox="1"/>
          <p:nvPr/>
        </p:nvSpPr>
        <p:spPr>
          <a:xfrm>
            <a:off x="1789430" y="4792345"/>
            <a:ext cx="8613140" cy="138366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just"/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orting Information S1: Figure 5</a:t>
            </a:r>
            <a:r>
              <a:rPr lang="en-US" sz="12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| 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The expression of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OsNAC78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and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ir7b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was not significant induced by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M.oryzae. 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(A) The expression levels of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OsNAC78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in WT (Nip) inoculated with Guy11 isolate at different time were detected by qRT-PCR. Mock, ddH</a:t>
            </a:r>
            <a:r>
              <a:rPr lang="en-US" sz="1200" baseline="-250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2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O treatment.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M.oryzae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,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M.oryzae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treatment.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OsUbq5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was used for the normalization.Values represent the mean±SE (n=3, n means biological replicate). Statistical significance was determined by one-way ANOVA (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&lt;0.05). (B) The expression levels of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ir7b 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in WT (Nip)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inoculated with Guy11 isolate at different time were detected by qRT-PCR. 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Mock, ddH</a:t>
            </a:r>
            <a:r>
              <a:rPr lang="en-US" sz="1200" baseline="-250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2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O treatment.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M.oryzae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,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M.oryzae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treatment. 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OsUbq5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was used for the normalization. Values represent the mean±SE (n=3, n means biological replicate). Statistical significance was determined by one-way ANOVA (</a:t>
            </a:r>
            <a:r>
              <a:rPr lang="en-US" sz="12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P</a:t>
            </a:r>
            <a:r>
              <a:rPr lang="en-US" sz="12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&lt;0.05).</a:t>
            </a:r>
            <a:endParaRPr lang="en-US" altLang="en-US" sz="12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53540" y="1473200"/>
            <a:ext cx="8884920" cy="3193415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  <p:tag name="KSO_WM_DIAGRAM_VIRTUALLY_FRAME" val="{&quot;height&quot;:142.15,&quot;left&quot;:162.8,&quot;top&quot;:217.7,&quot;width&quot;:363.65}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  <p:tag name="KSO_WM_DIAGRAM_VIRTUALLY_FRAME" val="{&quot;height&quot;:142.15,&quot;left&quot;:162.8,&quot;top&quot;:217.7,&quot;width&quot;:363.65}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  <p:tag name="KSO_WM_DIAGRAM_VIRTUALLY_FRAME" val="{&quot;height&quot;:142.15,&quot;left&quot;:162.8,&quot;top&quot;:217.7,&quot;width&quot;:363.65}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94</Words>
  <Application>WPS 演示</Application>
  <PresentationFormat>宽屏</PresentationFormat>
  <Paragraphs>74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余想珍</dc:creator>
  <cp:lastModifiedBy>xyj</cp:lastModifiedBy>
  <cp:revision>12</cp:revision>
  <dcterms:created xsi:type="dcterms:W3CDTF">2023-08-09T12:44:00Z</dcterms:created>
  <dcterms:modified xsi:type="dcterms:W3CDTF">2025-12-06T13:07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3542</vt:lpwstr>
  </property>
  <property fmtid="{D5CDD505-2E9C-101B-9397-08002B2CF9AE}" pid="3" name="ICV">
    <vt:lpwstr>0FFB374EF87741258E9EC42A4DEF22FC_13</vt:lpwstr>
  </property>
</Properties>
</file>